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media/image1.png" ContentType="image/png"/>
  <Override PartName="/ppt/media/image2.png" ContentType="image/png"/>
  <Override PartName="/ppt/media/image3.png" ContentType="image/png"/>
  <Override PartName="/ppt/media/image4.wmf" ContentType="image/x-wmf"/>
  <Override PartName="/ppt/media/image10.png" ContentType="image/png"/>
  <Override PartName="/ppt/media/image5.wmf" ContentType="image/x-wmf"/>
  <Override PartName="/ppt/media/image6.wmf" ContentType="image/x-wmf"/>
  <Override PartName="/ppt/media/image7.wmf" ContentType="image/x-wmf"/>
  <Override PartName="/ppt/media/image8.wmf" ContentType="image/x-wmf"/>
  <Override PartName="/ppt/media/image9.wmf" ContentType="image/x-wmf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</p:sldIdLst>
  <p:sldSz cx="9144000" cy="6858000"/>
  <p:notesSz cx="6664325" cy="98313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DBCA4B-2F81-4AE0-A849-C7322628868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31" name="PlaceHolder 2"/>
          <p:cNvSpPr>
            <a:spLocks noGrp="1"/>
          </p:cNvSpPr>
          <p:nvPr>
            <p:ph/>
          </p:nvPr>
        </p:nvSpPr>
        <p:spPr>
          <a:xfrm>
            <a:off x="626760" y="1442880"/>
            <a:ext cx="661356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3"/>
          <p:cNvSpPr>
            <a:spLocks noGrp="1"/>
          </p:cNvSpPr>
          <p:nvPr>
            <p:ph/>
          </p:nvPr>
        </p:nvSpPr>
        <p:spPr>
          <a:xfrm>
            <a:off x="626760" y="3926880"/>
            <a:ext cx="661356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AF669B-24A7-4B4D-9357-615CFBA726F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34" name="PlaceHolder 2"/>
          <p:cNvSpPr>
            <a:spLocks noGrp="1"/>
          </p:cNvSpPr>
          <p:nvPr>
            <p:ph/>
          </p:nvPr>
        </p:nvSpPr>
        <p:spPr>
          <a:xfrm>
            <a:off x="626760" y="1442880"/>
            <a:ext cx="3227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3"/>
          <p:cNvSpPr>
            <a:spLocks noGrp="1"/>
          </p:cNvSpPr>
          <p:nvPr>
            <p:ph/>
          </p:nvPr>
        </p:nvSpPr>
        <p:spPr>
          <a:xfrm>
            <a:off x="4015800" y="1442880"/>
            <a:ext cx="3227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4"/>
          <p:cNvSpPr>
            <a:spLocks noGrp="1"/>
          </p:cNvSpPr>
          <p:nvPr>
            <p:ph/>
          </p:nvPr>
        </p:nvSpPr>
        <p:spPr>
          <a:xfrm>
            <a:off x="626760" y="3926880"/>
            <a:ext cx="3227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5"/>
          <p:cNvSpPr>
            <a:spLocks noGrp="1"/>
          </p:cNvSpPr>
          <p:nvPr>
            <p:ph/>
          </p:nvPr>
        </p:nvSpPr>
        <p:spPr>
          <a:xfrm>
            <a:off x="4015800" y="3926880"/>
            <a:ext cx="3227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368293-52CA-4588-A447-D8484284932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39" name="PlaceHolder 2"/>
          <p:cNvSpPr>
            <a:spLocks noGrp="1"/>
          </p:cNvSpPr>
          <p:nvPr>
            <p:ph/>
          </p:nvPr>
        </p:nvSpPr>
        <p:spPr>
          <a:xfrm>
            <a:off x="626760" y="1442880"/>
            <a:ext cx="2129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3"/>
          <p:cNvSpPr>
            <a:spLocks noGrp="1"/>
          </p:cNvSpPr>
          <p:nvPr>
            <p:ph/>
          </p:nvPr>
        </p:nvSpPr>
        <p:spPr>
          <a:xfrm>
            <a:off x="2863080" y="1442880"/>
            <a:ext cx="2129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" name="PlaceHolder 4"/>
          <p:cNvSpPr>
            <a:spLocks noGrp="1"/>
          </p:cNvSpPr>
          <p:nvPr>
            <p:ph/>
          </p:nvPr>
        </p:nvSpPr>
        <p:spPr>
          <a:xfrm>
            <a:off x="5099400" y="1442880"/>
            <a:ext cx="2129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5"/>
          <p:cNvSpPr>
            <a:spLocks noGrp="1"/>
          </p:cNvSpPr>
          <p:nvPr>
            <p:ph/>
          </p:nvPr>
        </p:nvSpPr>
        <p:spPr>
          <a:xfrm>
            <a:off x="626760" y="3926880"/>
            <a:ext cx="2129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6"/>
          <p:cNvSpPr>
            <a:spLocks noGrp="1"/>
          </p:cNvSpPr>
          <p:nvPr>
            <p:ph/>
          </p:nvPr>
        </p:nvSpPr>
        <p:spPr>
          <a:xfrm>
            <a:off x="2863080" y="3926880"/>
            <a:ext cx="2129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7"/>
          <p:cNvSpPr>
            <a:spLocks noGrp="1"/>
          </p:cNvSpPr>
          <p:nvPr>
            <p:ph/>
          </p:nvPr>
        </p:nvSpPr>
        <p:spPr>
          <a:xfrm>
            <a:off x="5099400" y="3926880"/>
            <a:ext cx="2129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F2BA35-DF7E-4FD0-B922-6FE7DB8D0BE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53" name="PlaceHolder 2"/>
          <p:cNvSpPr>
            <a:spLocks noGrp="1"/>
          </p:cNvSpPr>
          <p:nvPr>
            <p:ph type="subTitle"/>
          </p:nvPr>
        </p:nvSpPr>
        <p:spPr>
          <a:xfrm>
            <a:off x="626760" y="1442880"/>
            <a:ext cx="6613560" cy="4754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55" name="PlaceHolder 2"/>
          <p:cNvSpPr>
            <a:spLocks noGrp="1"/>
          </p:cNvSpPr>
          <p:nvPr>
            <p:ph/>
          </p:nvPr>
        </p:nvSpPr>
        <p:spPr>
          <a:xfrm>
            <a:off x="626760" y="1442880"/>
            <a:ext cx="6613560" cy="475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57" name="PlaceHolder 2"/>
          <p:cNvSpPr>
            <a:spLocks noGrp="1"/>
          </p:cNvSpPr>
          <p:nvPr>
            <p:ph/>
          </p:nvPr>
        </p:nvSpPr>
        <p:spPr>
          <a:xfrm>
            <a:off x="626760" y="1442880"/>
            <a:ext cx="3227400" cy="475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3"/>
          <p:cNvSpPr>
            <a:spLocks noGrp="1"/>
          </p:cNvSpPr>
          <p:nvPr>
            <p:ph/>
          </p:nvPr>
        </p:nvSpPr>
        <p:spPr>
          <a:xfrm>
            <a:off x="4015800" y="1442880"/>
            <a:ext cx="3227400" cy="475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PlaceHolder 1"/>
          <p:cNvSpPr>
            <a:spLocks noGrp="1"/>
          </p:cNvSpPr>
          <p:nvPr>
            <p:ph type="subTitle"/>
          </p:nvPr>
        </p:nvSpPr>
        <p:spPr>
          <a:xfrm>
            <a:off x="599760" y="-360"/>
            <a:ext cx="6645240" cy="5873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62" name="PlaceHolder 2"/>
          <p:cNvSpPr>
            <a:spLocks noGrp="1"/>
          </p:cNvSpPr>
          <p:nvPr>
            <p:ph/>
          </p:nvPr>
        </p:nvSpPr>
        <p:spPr>
          <a:xfrm>
            <a:off x="626760" y="1442880"/>
            <a:ext cx="3227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PlaceHolder 3"/>
          <p:cNvSpPr>
            <a:spLocks noGrp="1"/>
          </p:cNvSpPr>
          <p:nvPr>
            <p:ph/>
          </p:nvPr>
        </p:nvSpPr>
        <p:spPr>
          <a:xfrm>
            <a:off x="4015800" y="1442880"/>
            <a:ext cx="3227400" cy="475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4"/>
          <p:cNvSpPr>
            <a:spLocks noGrp="1"/>
          </p:cNvSpPr>
          <p:nvPr>
            <p:ph/>
          </p:nvPr>
        </p:nvSpPr>
        <p:spPr>
          <a:xfrm>
            <a:off x="626760" y="3926880"/>
            <a:ext cx="3227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 type="subTitle"/>
          </p:nvPr>
        </p:nvSpPr>
        <p:spPr>
          <a:xfrm>
            <a:off x="626760" y="1442880"/>
            <a:ext cx="6613560" cy="4754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F3F5BE-0F9B-4C5E-ADB9-BC553C07376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66" name="PlaceHolder 2"/>
          <p:cNvSpPr>
            <a:spLocks noGrp="1"/>
          </p:cNvSpPr>
          <p:nvPr>
            <p:ph/>
          </p:nvPr>
        </p:nvSpPr>
        <p:spPr>
          <a:xfrm>
            <a:off x="626760" y="1442880"/>
            <a:ext cx="3227400" cy="475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PlaceHolder 3"/>
          <p:cNvSpPr>
            <a:spLocks noGrp="1"/>
          </p:cNvSpPr>
          <p:nvPr>
            <p:ph/>
          </p:nvPr>
        </p:nvSpPr>
        <p:spPr>
          <a:xfrm>
            <a:off x="4015800" y="1442880"/>
            <a:ext cx="3227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4"/>
          <p:cNvSpPr>
            <a:spLocks noGrp="1"/>
          </p:cNvSpPr>
          <p:nvPr>
            <p:ph/>
          </p:nvPr>
        </p:nvSpPr>
        <p:spPr>
          <a:xfrm>
            <a:off x="4015800" y="3926880"/>
            <a:ext cx="3227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70" name="PlaceHolder 2"/>
          <p:cNvSpPr>
            <a:spLocks noGrp="1"/>
          </p:cNvSpPr>
          <p:nvPr>
            <p:ph/>
          </p:nvPr>
        </p:nvSpPr>
        <p:spPr>
          <a:xfrm>
            <a:off x="626760" y="1442880"/>
            <a:ext cx="3227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3"/>
          <p:cNvSpPr>
            <a:spLocks noGrp="1"/>
          </p:cNvSpPr>
          <p:nvPr>
            <p:ph/>
          </p:nvPr>
        </p:nvSpPr>
        <p:spPr>
          <a:xfrm>
            <a:off x="4015800" y="1442880"/>
            <a:ext cx="3227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4"/>
          <p:cNvSpPr>
            <a:spLocks noGrp="1"/>
          </p:cNvSpPr>
          <p:nvPr>
            <p:ph/>
          </p:nvPr>
        </p:nvSpPr>
        <p:spPr>
          <a:xfrm>
            <a:off x="626760" y="3926880"/>
            <a:ext cx="661356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74" name="PlaceHolder 2"/>
          <p:cNvSpPr>
            <a:spLocks noGrp="1"/>
          </p:cNvSpPr>
          <p:nvPr>
            <p:ph/>
          </p:nvPr>
        </p:nvSpPr>
        <p:spPr>
          <a:xfrm>
            <a:off x="626760" y="1442880"/>
            <a:ext cx="661356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PlaceHolder 3"/>
          <p:cNvSpPr>
            <a:spLocks noGrp="1"/>
          </p:cNvSpPr>
          <p:nvPr>
            <p:ph/>
          </p:nvPr>
        </p:nvSpPr>
        <p:spPr>
          <a:xfrm>
            <a:off x="626760" y="3926880"/>
            <a:ext cx="661356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77" name="PlaceHolder 2"/>
          <p:cNvSpPr>
            <a:spLocks noGrp="1"/>
          </p:cNvSpPr>
          <p:nvPr>
            <p:ph/>
          </p:nvPr>
        </p:nvSpPr>
        <p:spPr>
          <a:xfrm>
            <a:off x="626760" y="1442880"/>
            <a:ext cx="3227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3"/>
          <p:cNvSpPr>
            <a:spLocks noGrp="1"/>
          </p:cNvSpPr>
          <p:nvPr>
            <p:ph/>
          </p:nvPr>
        </p:nvSpPr>
        <p:spPr>
          <a:xfrm>
            <a:off x="4015800" y="1442880"/>
            <a:ext cx="3227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4"/>
          <p:cNvSpPr>
            <a:spLocks noGrp="1"/>
          </p:cNvSpPr>
          <p:nvPr>
            <p:ph/>
          </p:nvPr>
        </p:nvSpPr>
        <p:spPr>
          <a:xfrm>
            <a:off x="626760" y="3926880"/>
            <a:ext cx="3227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5"/>
          <p:cNvSpPr>
            <a:spLocks noGrp="1"/>
          </p:cNvSpPr>
          <p:nvPr>
            <p:ph/>
          </p:nvPr>
        </p:nvSpPr>
        <p:spPr>
          <a:xfrm>
            <a:off x="4015800" y="3926880"/>
            <a:ext cx="3227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82" name="PlaceHolder 2"/>
          <p:cNvSpPr>
            <a:spLocks noGrp="1"/>
          </p:cNvSpPr>
          <p:nvPr>
            <p:ph/>
          </p:nvPr>
        </p:nvSpPr>
        <p:spPr>
          <a:xfrm>
            <a:off x="626760" y="1442880"/>
            <a:ext cx="2129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PlaceHolder 3"/>
          <p:cNvSpPr>
            <a:spLocks noGrp="1"/>
          </p:cNvSpPr>
          <p:nvPr>
            <p:ph/>
          </p:nvPr>
        </p:nvSpPr>
        <p:spPr>
          <a:xfrm>
            <a:off x="2863080" y="1442880"/>
            <a:ext cx="2129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PlaceHolder 4"/>
          <p:cNvSpPr>
            <a:spLocks noGrp="1"/>
          </p:cNvSpPr>
          <p:nvPr>
            <p:ph/>
          </p:nvPr>
        </p:nvSpPr>
        <p:spPr>
          <a:xfrm>
            <a:off x="5099400" y="1442880"/>
            <a:ext cx="2129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PlaceHolder 5"/>
          <p:cNvSpPr>
            <a:spLocks noGrp="1"/>
          </p:cNvSpPr>
          <p:nvPr>
            <p:ph/>
          </p:nvPr>
        </p:nvSpPr>
        <p:spPr>
          <a:xfrm>
            <a:off x="626760" y="3926880"/>
            <a:ext cx="2129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PlaceHolder 6"/>
          <p:cNvSpPr>
            <a:spLocks noGrp="1"/>
          </p:cNvSpPr>
          <p:nvPr>
            <p:ph/>
          </p:nvPr>
        </p:nvSpPr>
        <p:spPr>
          <a:xfrm>
            <a:off x="2863080" y="3926880"/>
            <a:ext cx="2129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PlaceHolder 7"/>
          <p:cNvSpPr>
            <a:spLocks noGrp="1"/>
          </p:cNvSpPr>
          <p:nvPr>
            <p:ph/>
          </p:nvPr>
        </p:nvSpPr>
        <p:spPr>
          <a:xfrm>
            <a:off x="5099400" y="3926880"/>
            <a:ext cx="2129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/>
          </p:nvPr>
        </p:nvSpPr>
        <p:spPr>
          <a:xfrm>
            <a:off x="626760" y="1442880"/>
            <a:ext cx="6613560" cy="475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E6508C-E9AA-481E-AD18-8084AED0C85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14" name="PlaceHolder 2"/>
          <p:cNvSpPr>
            <a:spLocks noGrp="1"/>
          </p:cNvSpPr>
          <p:nvPr>
            <p:ph/>
          </p:nvPr>
        </p:nvSpPr>
        <p:spPr>
          <a:xfrm>
            <a:off x="626760" y="1442880"/>
            <a:ext cx="3227400" cy="475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3"/>
          <p:cNvSpPr>
            <a:spLocks noGrp="1"/>
          </p:cNvSpPr>
          <p:nvPr>
            <p:ph/>
          </p:nvPr>
        </p:nvSpPr>
        <p:spPr>
          <a:xfrm>
            <a:off x="4015800" y="1442880"/>
            <a:ext cx="3227400" cy="475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D19F6D-58D9-4432-B5F2-461D507B10F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38C197-0425-4A3C-B40B-8D0E08EC25B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PlaceHolder 1"/>
          <p:cNvSpPr>
            <a:spLocks noGrp="1"/>
          </p:cNvSpPr>
          <p:nvPr>
            <p:ph type="subTitle"/>
          </p:nvPr>
        </p:nvSpPr>
        <p:spPr>
          <a:xfrm>
            <a:off x="599760" y="-360"/>
            <a:ext cx="6645240" cy="5873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EFAA51-AA09-43CC-A3A4-B5794AEA612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6760" y="1442880"/>
            <a:ext cx="3227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015800" y="1442880"/>
            <a:ext cx="3227400" cy="475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6760" y="3926880"/>
            <a:ext cx="3227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DA34BA-5585-483D-B3E8-9DF16652A89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6760" y="1442880"/>
            <a:ext cx="3227400" cy="475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015800" y="1442880"/>
            <a:ext cx="3227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015800" y="3926880"/>
            <a:ext cx="3227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33069B-4D8C-434F-9B3E-25FB3C8FA0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6760" y="1442880"/>
            <a:ext cx="3227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015800" y="1442880"/>
            <a:ext cx="3227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/>
          </p:nvPr>
        </p:nvSpPr>
        <p:spPr>
          <a:xfrm>
            <a:off x="626760" y="3926880"/>
            <a:ext cx="661356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7F7EFF-3C3E-4002-A3AA-E1AA9ACDBD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1.xml"/><Relationship Id="rId4" Type="http://schemas.openxmlformats.org/officeDocument/2006/relationships/slideLayout" Target="../slideLayouts/slideLayout2.xml"/><Relationship Id="rId5" Type="http://schemas.openxmlformats.org/officeDocument/2006/relationships/slideLayout" Target="../slideLayouts/slideLayout3.xml"/><Relationship Id="rId6" Type="http://schemas.openxmlformats.org/officeDocument/2006/relationships/slideLayout" Target="../slideLayouts/slideLayout4.xml"/><Relationship Id="rId7" Type="http://schemas.openxmlformats.org/officeDocument/2006/relationships/slideLayout" Target="../slideLayouts/slideLayout5.xml"/><Relationship Id="rId8" Type="http://schemas.openxmlformats.org/officeDocument/2006/relationships/slideLayout" Target="../slideLayouts/slideLayout6.xml"/><Relationship Id="rId9" Type="http://schemas.openxmlformats.org/officeDocument/2006/relationships/slideLayout" Target="../slideLayouts/slideLayout7.xml"/><Relationship Id="rId10" Type="http://schemas.openxmlformats.org/officeDocument/2006/relationships/slideLayout" Target="../slideLayouts/slideLayout8.xml"/><Relationship Id="rId11" Type="http://schemas.openxmlformats.org/officeDocument/2006/relationships/slideLayout" Target="../slideLayouts/slideLayout9.xml"/><Relationship Id="rId12" Type="http://schemas.openxmlformats.org/officeDocument/2006/relationships/slideLayout" Target="../slideLayouts/slideLayout10.xml"/><Relationship Id="rId13" Type="http://schemas.openxmlformats.org/officeDocument/2006/relationships/slideLayout" Target="../slideLayouts/slideLayout11.xml"/><Relationship Id="rId14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3.xml"/><Relationship Id="rId5" Type="http://schemas.openxmlformats.org/officeDocument/2006/relationships/slideLayout" Target="../slideLayouts/slideLayout14.xml"/><Relationship Id="rId6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6.xml"/><Relationship Id="rId8" Type="http://schemas.openxmlformats.org/officeDocument/2006/relationships/slideLayout" Target="../slideLayouts/slideLayout17.xml"/><Relationship Id="rId9" Type="http://schemas.openxmlformats.org/officeDocument/2006/relationships/slideLayout" Target="../slideLayouts/slideLayout18.xml"/><Relationship Id="rId10" Type="http://schemas.openxmlformats.org/officeDocument/2006/relationships/slideLayout" Target="../slideLayouts/slideLayout19.xml"/><Relationship Id="rId11" Type="http://schemas.openxmlformats.org/officeDocument/2006/relationships/slideLayout" Target="../slideLayouts/slideLayout20.xml"/><Relationship Id="rId12" Type="http://schemas.openxmlformats.org/officeDocument/2006/relationships/slideLayout" Target="../slideLayouts/slideLayout21.xml"/><Relationship Id="rId13" Type="http://schemas.openxmlformats.org/officeDocument/2006/relationships/slideLayout" Target="../slideLayouts/slideLayout22.xml"/><Relationship Id="rId14" Type="http://schemas.openxmlformats.org/officeDocument/2006/relationships/slideLayout" Target="../slideLayouts/slideLayout23.xml"/><Relationship Id="rId15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0" name="" descr=""/>
          <p:cNvPicPr/>
          <p:nvPr/>
        </p:nvPicPr>
        <p:blipFill>
          <a:blip r:embed="rId2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  <p:sp>
        <p:nvSpPr>
          <p:cNvPr id="1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e80000"/>
                </a:solidFill>
                <a:latin typeface="Tahoma"/>
              </a:rPr>
              <a:t>Click to edit the title text format</a:t>
            </a: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2" name="PlaceHolder 2"/>
          <p:cNvSpPr>
            <a:spLocks noGrp="1"/>
          </p:cNvSpPr>
          <p:nvPr>
            <p:ph type="body"/>
          </p:nvPr>
        </p:nvSpPr>
        <p:spPr>
          <a:xfrm>
            <a:off x="626760" y="1442880"/>
            <a:ext cx="6613560" cy="475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lvl="1" marL="343080" indent="-34308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Clr>
                <a:srgbClr val="000000"/>
              </a:buClr>
              <a:buSzPct val="120000"/>
              <a:buFont typeface="Arial"/>
              <a:buChar char="•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lvl="2" marL="343080" indent="-34308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Clr>
                <a:srgbClr val="000000"/>
              </a:buClr>
              <a:buSzPct val="120000"/>
              <a:buFont typeface="Arial"/>
              <a:buChar char="•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lvl="3" marL="343080" indent="-34308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Clr>
                <a:srgbClr val="000000"/>
              </a:buClr>
              <a:buSzPct val="120000"/>
              <a:buFont typeface="Arial"/>
              <a:buChar char="–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lvl="4" marL="343080" indent="-34308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Clr>
                <a:srgbClr val="000000"/>
              </a:buClr>
              <a:buSzPct val="120000"/>
              <a:buFont typeface="Arial"/>
              <a:buChar char="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lvl="5" marL="343080" indent="-34308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Clr>
                <a:srgbClr val="000000"/>
              </a:buClr>
              <a:buSzPct val="120000"/>
              <a:buFont typeface="Arial"/>
              <a:buChar char="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lvl="6" marL="343080" indent="-34308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Clr>
                <a:srgbClr val="000000"/>
              </a:buClr>
              <a:buSzPct val="120000"/>
              <a:buFont typeface="Arial"/>
              <a:buChar char="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3"/>
          <p:cNvSpPr>
            <a:spLocks noGrp="1"/>
          </p:cNvSpPr>
          <p:nvPr>
            <p:ph type="dt" idx="1"/>
          </p:nvPr>
        </p:nvSpPr>
        <p:spPr>
          <a:xfrm>
            <a:off x="5946840" y="6388200"/>
            <a:ext cx="3052800" cy="31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0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403C294-3C50-4425-934D-2C5488713515}" type="datetime2">
              <a:rPr b="0" lang="en-GB" sz="1000" spc="-1" strike="noStrike">
                <a:solidFill>
                  <a:srgbClr val="000000"/>
                </a:solidFill>
                <a:latin typeface="Arial"/>
              </a:rPr>
              <a:t>Saturday 29 August 2026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ftr" idx="2"/>
          </p:nvPr>
        </p:nvSpPr>
        <p:spPr>
          <a:xfrm>
            <a:off x="1697040" y="6388200"/>
            <a:ext cx="4121280" cy="31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0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5"/>
          <p:cNvSpPr>
            <a:spLocks noGrp="1"/>
          </p:cNvSpPr>
          <p:nvPr>
            <p:ph type="sldNum" idx="3"/>
          </p:nvPr>
        </p:nvSpPr>
        <p:spPr>
          <a:xfrm>
            <a:off x="1297080" y="6389640"/>
            <a:ext cx="371520" cy="31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0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9F709B1-A982-438E-AE47-700BA6B23519}" type="slidenum">
              <a:rPr b="0" lang="en-US" sz="10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"/>
          <p:cNvSpPr/>
          <p:nvPr/>
        </p:nvSpPr>
        <p:spPr>
          <a:xfrm>
            <a:off x="0" y="1281240"/>
            <a:ext cx="7245360" cy="0"/>
          </a:xfrm>
          <a:prstGeom prst="line">
            <a:avLst/>
          </a:prstGeom>
          <a:ln w="9360">
            <a:solidFill>
              <a:srgbClr val="77777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"/>
          <p:cNvSpPr/>
          <p:nvPr/>
        </p:nvSpPr>
        <p:spPr>
          <a:xfrm>
            <a:off x="1297080" y="6307200"/>
            <a:ext cx="7846920" cy="0"/>
          </a:xfrm>
          <a:prstGeom prst="line">
            <a:avLst/>
          </a:prstGeom>
          <a:ln w="9360">
            <a:solidFill>
              <a:srgbClr val="77777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"/>
          <p:cNvSpPr/>
          <p:nvPr/>
        </p:nvSpPr>
        <p:spPr>
          <a:xfrm>
            <a:off x="6877080" y="6454800"/>
            <a:ext cx="2163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© Blackwell Publishing Ltd 2007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3"/>
    <p:sldLayoutId id="2147483650" r:id="rId4"/>
    <p:sldLayoutId id="2147483651" r:id="rId5"/>
    <p:sldLayoutId id="2147483652" r:id="rId6"/>
    <p:sldLayoutId id="2147483653" r:id="rId7"/>
    <p:sldLayoutId id="2147483654" r:id="rId8"/>
    <p:sldLayoutId id="2147483655" r:id="rId9"/>
    <p:sldLayoutId id="2147483656" r:id="rId10"/>
    <p:sldLayoutId id="2147483657" r:id="rId11"/>
    <p:sldLayoutId id="2147483658" r:id="rId12"/>
    <p:sldLayoutId id="2147483659" r:id="rId13"/>
    <p:sldLayoutId id="2147483660" r:id="rId14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" descr=""/>
          <p:cNvPicPr/>
          <p:nvPr/>
        </p:nvPicPr>
        <p:blipFill>
          <a:blip r:embed="rId2"/>
          <a:stretch/>
        </p:blipFill>
        <p:spPr>
          <a:xfrm>
            <a:off x="0" y="-1440"/>
            <a:ext cx="9144000" cy="6859440"/>
          </a:xfrm>
          <a:prstGeom prst="rect">
            <a:avLst/>
          </a:prstGeom>
          <a:ln w="0">
            <a:noFill/>
          </a:ln>
        </p:spPr>
      </p:pic>
      <p:pic>
        <p:nvPicPr>
          <p:cNvPr id="46" name="" descr=""/>
          <p:cNvPicPr/>
          <p:nvPr/>
        </p:nvPicPr>
        <p:blipFill>
          <a:blip r:embed="rId3"/>
          <a:srcRect l="0" t="0" r="0" b="27346"/>
          <a:stretch/>
        </p:blipFill>
        <p:spPr>
          <a:xfrm>
            <a:off x="569880" y="333360"/>
            <a:ext cx="3641760" cy="719280"/>
          </a:xfrm>
          <a:prstGeom prst="rect">
            <a:avLst/>
          </a:prstGeom>
          <a:ln w="0">
            <a:noFill/>
          </a:ln>
        </p:spPr>
      </p:pic>
      <p:sp>
        <p:nvSpPr>
          <p:cNvPr id="47" name=""/>
          <p:cNvSpPr/>
          <p:nvPr/>
        </p:nvSpPr>
        <p:spPr>
          <a:xfrm>
            <a:off x="0" y="1052640"/>
            <a:ext cx="4211640" cy="0"/>
          </a:xfrm>
          <a:prstGeom prst="line">
            <a:avLst/>
          </a:prstGeom>
          <a:ln w="9360">
            <a:solidFill>
              <a:srgbClr val="77777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6877080" y="6454800"/>
            <a:ext cx="2163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© Blackwell Publishing Ltd 2007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539640" y="1440000"/>
            <a:ext cx="3527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808080"/>
                </a:solidFill>
                <a:latin typeface="Arial"/>
              </a:rPr>
              <a:t>Slides to accompany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e80000"/>
                </a:solidFill>
                <a:latin typeface="Arial"/>
              </a:rPr>
              <a:t>Click to edit the title text format</a:t>
            </a:r>
            <a:endParaRPr b="1" lang="en-US" sz="2400" spc="-1" strike="noStrike">
              <a:solidFill>
                <a:srgbClr val="e80000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lvl="1" marL="457200" indent="0" algn="ctr">
              <a:lnSpc>
                <a:spcPct val="105000"/>
              </a:lnSpc>
              <a:spcBef>
                <a:spcPts val="425"/>
              </a:spcBef>
              <a:spcAft>
                <a:spcPts val="52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  <a:p>
            <a:pPr lvl="2" marL="914400" algn="ctr">
              <a:lnSpc>
                <a:spcPct val="105000"/>
              </a:lnSpc>
              <a:spcBef>
                <a:spcPts val="374"/>
              </a:spcBef>
              <a:spcAft>
                <a:spcPts val="462"/>
              </a:spcAft>
              <a:buClr>
                <a:srgbClr val="000000"/>
              </a:buClr>
              <a:buSzPct val="120000"/>
              <a:buFont typeface="Arial"/>
              <a:buChar char="•"/>
              <a:tabLst>
                <a:tab algn="l" pos="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lvl="3" marL="1371600" algn="ctr">
              <a:spcBef>
                <a:spcPts val="374"/>
              </a:spcBef>
              <a:buClr>
                <a:srgbClr val="000000"/>
              </a:buClr>
              <a:buSzPct val="120000"/>
              <a:buFont typeface="Arial"/>
              <a:buChar char="–"/>
              <a:tabLst>
                <a:tab algn="l" pos="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lvl="4" marL="1828800" algn="ctr">
              <a:spcBef>
                <a:spcPts val="374"/>
              </a:spcBef>
              <a:buClr>
                <a:srgbClr val="000000"/>
              </a:buClr>
              <a:buSzPct val="120000"/>
              <a:buFont typeface="Arial"/>
              <a:buChar char="»"/>
              <a:tabLst>
                <a:tab algn="l" pos="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lvl="5" marL="1828800">
              <a:spcBef>
                <a:spcPts val="374"/>
              </a:spcBef>
              <a:buClr>
                <a:srgbClr val="000000"/>
              </a:buClr>
              <a:buSzPct val="120000"/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lvl="6" marL="1828800">
              <a:spcBef>
                <a:spcPts val="374"/>
              </a:spcBef>
              <a:buClr>
                <a:srgbClr val="000000"/>
              </a:buClr>
              <a:buSzPct val="120000"/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4"/>
    <p:sldLayoutId id="2147483663" r:id="rId5"/>
    <p:sldLayoutId id="2147483664" r:id="rId6"/>
    <p:sldLayoutId id="2147483665" r:id="rId7"/>
    <p:sldLayoutId id="2147483666" r:id="rId8"/>
    <p:sldLayoutId id="2147483667" r:id="rId9"/>
    <p:sldLayoutId id="2147483668" r:id="rId10"/>
    <p:sldLayoutId id="2147483669" r:id="rId11"/>
    <p:sldLayoutId id="2147483670" r:id="rId12"/>
    <p:sldLayoutId id="2147483671" r:id="rId13"/>
    <p:sldLayoutId id="2147483672" r:id="rId14"/>
    <p:sldLayoutId id="2147483673" r:id="rId15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4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4.wmf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5.wmf"/><Relationship Id="rId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6.wmf"/><Relationship Id="rId3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7.wmf"/><Relationship Id="rId3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8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9.wmf"/><Relationship Id="rId5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PlaceHolder 1"/>
          <p:cNvSpPr>
            <a:spLocks noGrp="1"/>
          </p:cNvSpPr>
          <p:nvPr>
            <p:ph type="title"/>
          </p:nvPr>
        </p:nvSpPr>
        <p:spPr>
          <a:xfrm>
            <a:off x="539640" y="1728360"/>
            <a:ext cx="806472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e80000"/>
                </a:solidFill>
                <a:latin typeface="Arial"/>
              </a:rPr>
              <a:t>A Well-being programme in Severe Mental Illness. Baseline findings in a UK cohort.</a:t>
            </a:r>
            <a:endParaRPr b="1" lang="en-US" sz="2400" spc="-1" strike="noStrike">
              <a:solidFill>
                <a:srgbClr val="e8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539640" y="4141800"/>
            <a:ext cx="777564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"/>
          <p:cNvSpPr/>
          <p:nvPr/>
        </p:nvSpPr>
        <p:spPr>
          <a:xfrm>
            <a:off x="450720" y="3260880"/>
            <a:ext cx="18432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"/>
          <p:cNvSpPr/>
          <p:nvPr/>
        </p:nvSpPr>
        <p:spPr>
          <a:xfrm>
            <a:off x="611280" y="4076640"/>
            <a:ext cx="7705800" cy="1919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O Box 23, Institute of Psychiatry, Decrespigny Park, Camberwell, London SE5 8AF, UK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Leeds Mental Health Teaching NHS Trust, Clarence House, 11 Clarence Road, Horsforth, Leeds, LS18 4LB, UK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 baseline="30000">
                <a:solidFill>
                  <a:srgbClr val="000000"/>
                </a:solidFill>
                <a:latin typeface="Arial"/>
              </a:rPr>
              <a:t>3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Eli Lilly and Company Ltd, Basingstoke, UK, Lilly House, Priestley Road, Basingstoke, RG24 9NL, UK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 baseline="30000">
                <a:solidFill>
                  <a:srgbClr val="000000"/>
                </a:solidFill>
                <a:latin typeface="Arial"/>
              </a:rPr>
              <a:t>4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carborough House, 35 Auckland Road, Sparkbrook, Birmingham. B11 1RH, UK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 baseline="30000">
                <a:solidFill>
                  <a:srgbClr val="000000"/>
                </a:solidFill>
                <a:latin typeface="Arial"/>
              </a:rPr>
              <a:t>5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aludon Centre, Clifford Bridge Rd, Coventry. CV2 2TE, UK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 baseline="30000">
                <a:solidFill>
                  <a:srgbClr val="000000"/>
                </a:solidFill>
                <a:latin typeface="Arial"/>
              </a:rPr>
              <a:t>6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lderney Hospital, Ringwood Road, Poole. BH12 4NB, UK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 baseline="30000">
                <a:solidFill>
                  <a:srgbClr val="000000"/>
                </a:solidFill>
                <a:latin typeface="Arial"/>
              </a:rPr>
              <a:t>7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eesbay Unit, St.Lukes Hospital, Martan Road, Middlesbrough. TS4 3AF, UK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 baseline="30000">
                <a:solidFill>
                  <a:srgbClr val="000000"/>
                </a:solidFill>
                <a:latin typeface="Arial"/>
              </a:rPr>
              <a:t>8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t.Tydfils Hospital, Merthyr Tydfil, South Wales. CF47 0SJ, UK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orresponding author: Shubulade Smith, Email: - s.smith@iop.kcl.ac.uk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2" name=""/>
          <p:cNvSpPr/>
          <p:nvPr/>
        </p:nvSpPr>
        <p:spPr>
          <a:xfrm>
            <a:off x="557280" y="2708280"/>
            <a:ext cx="7632720" cy="1067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Arial"/>
              </a:rPr>
              <a:t>Shubulade Smith MRCPsych</a:t>
            </a:r>
            <a:r>
              <a:rPr b="0" lang="en-GB" sz="16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r>
              <a:rPr b="0" lang="en-GB" sz="1600" spc="-1" strike="noStrike">
                <a:solidFill>
                  <a:srgbClr val="000000"/>
                </a:solidFill>
                <a:latin typeface="Arial"/>
              </a:rPr>
              <a:t>, David Yeomans MRCPsych</a:t>
            </a:r>
            <a:r>
              <a:rPr b="0" lang="en-GB" sz="16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0" lang="en-GB" sz="1600" spc="-1" strike="noStrike">
                <a:solidFill>
                  <a:srgbClr val="000000"/>
                </a:solidFill>
                <a:latin typeface="Arial"/>
              </a:rPr>
              <a:t>, Chris JP Bushe MBBS</a:t>
            </a:r>
            <a:r>
              <a:rPr b="0" lang="en-GB" sz="1600" spc="-1" strike="noStrike" baseline="30000">
                <a:solidFill>
                  <a:srgbClr val="000000"/>
                </a:solidFill>
                <a:latin typeface="Arial"/>
              </a:rPr>
              <a:t>3</a:t>
            </a:r>
            <a:r>
              <a:rPr b="0" lang="en-GB" sz="1600" spc="-1" strike="noStrike">
                <a:solidFill>
                  <a:srgbClr val="000000"/>
                </a:solidFill>
                <a:latin typeface="Arial"/>
              </a:rPr>
              <a:t>, Cecilia Eriksson MBBS</a:t>
            </a:r>
            <a:r>
              <a:rPr b="0" lang="en-GB" sz="16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r>
              <a:rPr b="0" lang="en-GB" sz="1600" spc="-1" strike="noStrike">
                <a:solidFill>
                  <a:srgbClr val="000000"/>
                </a:solidFill>
                <a:latin typeface="Arial"/>
              </a:rPr>
              <a:t>, Tom Harrison MRCPsych</a:t>
            </a:r>
            <a:r>
              <a:rPr b="0" lang="en-GB" sz="1600" spc="-1" strike="noStrike" baseline="30000">
                <a:solidFill>
                  <a:srgbClr val="000000"/>
                </a:solidFill>
                <a:latin typeface="Arial"/>
              </a:rPr>
              <a:t>4</a:t>
            </a:r>
            <a:r>
              <a:rPr b="0" lang="en-GB" sz="1600" spc="-1" strike="noStrike">
                <a:solidFill>
                  <a:srgbClr val="000000"/>
                </a:solidFill>
                <a:latin typeface="Arial"/>
              </a:rPr>
              <a:t>, Robert Holmes MRCPsych</a:t>
            </a:r>
            <a:r>
              <a:rPr b="0" lang="en-GB" sz="1600" spc="-1" strike="noStrike" baseline="30000">
                <a:solidFill>
                  <a:srgbClr val="000000"/>
                </a:solidFill>
                <a:latin typeface="Arial"/>
              </a:rPr>
              <a:t>5</a:t>
            </a:r>
            <a:r>
              <a:rPr b="0" lang="en-GB" sz="1600" spc="-1" strike="noStrike">
                <a:solidFill>
                  <a:srgbClr val="000000"/>
                </a:solidFill>
                <a:latin typeface="Arial"/>
              </a:rPr>
              <a:t>, Laurence Mynors-Wallis MRCPsych</a:t>
            </a:r>
            <a:r>
              <a:rPr b="0" lang="en-GB" sz="1600" spc="-1" strike="noStrike" baseline="30000">
                <a:solidFill>
                  <a:srgbClr val="000000"/>
                </a:solidFill>
                <a:latin typeface="Arial"/>
              </a:rPr>
              <a:t>6</a:t>
            </a:r>
            <a:r>
              <a:rPr b="0" lang="en-GB" sz="1600" spc="-1" strike="noStrike">
                <a:solidFill>
                  <a:srgbClr val="000000"/>
                </a:solidFill>
                <a:latin typeface="Arial"/>
              </a:rPr>
              <a:t>, Helen Oatway MBBS</a:t>
            </a:r>
            <a:r>
              <a:rPr b="0" lang="en-GB" sz="1600" spc="-1" strike="noStrike" baseline="30000">
                <a:solidFill>
                  <a:srgbClr val="000000"/>
                </a:solidFill>
                <a:latin typeface="Arial"/>
              </a:rPr>
              <a:t>7</a:t>
            </a:r>
            <a:r>
              <a:rPr b="0" lang="en-GB" sz="1600" spc="-1" strike="noStrike">
                <a:solidFill>
                  <a:srgbClr val="000000"/>
                </a:solidFill>
                <a:latin typeface="Arial"/>
              </a:rPr>
              <a:t>, Gary Sullivan MRCPsych</a:t>
            </a:r>
            <a:r>
              <a:rPr b="0" lang="en-GB" sz="1600" spc="-1" strike="noStrike" baseline="30000">
                <a:solidFill>
                  <a:srgbClr val="000000"/>
                </a:solidFill>
                <a:latin typeface="Arial"/>
              </a:rPr>
              <a:t>8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400" spc="-1" strike="noStrike">
                <a:solidFill>
                  <a:srgbClr val="e80000"/>
                </a:solidFill>
                <a:latin typeface="Tahoma"/>
              </a:rPr>
              <a:t>What is the Wellbeing Support Programme?</a:t>
            </a: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94" name="PlaceHolder 2"/>
          <p:cNvSpPr>
            <a:spLocks noGrp="1"/>
          </p:cNvSpPr>
          <p:nvPr>
            <p:ph/>
          </p:nvPr>
        </p:nvSpPr>
        <p:spPr>
          <a:xfrm>
            <a:off x="627120" y="1442880"/>
            <a:ext cx="3230640" cy="475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444600" indent="0">
              <a:lnSpc>
                <a:spcPct val="105000"/>
              </a:lnSpc>
              <a:spcBef>
                <a:spcPts val="425"/>
              </a:spcBef>
              <a:spcAft>
                <a:spcPts val="524"/>
              </a:spcAft>
              <a:buNone/>
              <a:tabLst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  <a:p>
            <a:pPr marL="444600" indent="0">
              <a:lnSpc>
                <a:spcPct val="105000"/>
              </a:lnSpc>
              <a:spcBef>
                <a:spcPts val="425"/>
              </a:spcBef>
              <a:spcAft>
                <a:spcPts val="524"/>
              </a:spcAft>
              <a:buNone/>
              <a:tabLst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5" name=""/>
          <p:cNvGrpSpPr/>
          <p:nvPr/>
        </p:nvGrpSpPr>
        <p:grpSpPr>
          <a:xfrm>
            <a:off x="76320" y="2514600"/>
            <a:ext cx="6018480" cy="2590560"/>
            <a:chOff x="76320" y="2514600"/>
            <a:chExt cx="6018480" cy="2590560"/>
          </a:xfrm>
        </p:grpSpPr>
        <p:sp>
          <p:nvSpPr>
            <p:cNvPr id="96" name=""/>
            <p:cNvSpPr/>
            <p:nvPr/>
          </p:nvSpPr>
          <p:spPr>
            <a:xfrm>
              <a:off x="76320" y="2514600"/>
              <a:ext cx="6018480" cy="259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2967120" y="2842920"/>
              <a:ext cx="18072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98" name=""/>
          <p:cNvSpPr/>
          <p:nvPr/>
        </p:nvSpPr>
        <p:spPr>
          <a:xfrm>
            <a:off x="611280" y="1413000"/>
            <a:ext cx="7056360" cy="3014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327d"/>
                </a:solidFill>
                <a:latin typeface="Arial"/>
              </a:rPr>
              <a:t>7 Mental Health Trusts in England and Wales agreed to take </a:t>
            </a:r>
            <a:br>
              <a:rPr sz="1600"/>
            </a:br>
            <a:r>
              <a:rPr b="0" lang="en-GB" sz="1600" spc="-1" strike="noStrike">
                <a:solidFill>
                  <a:srgbClr val="00327d"/>
                </a:solidFill>
                <a:latin typeface="Arial"/>
              </a:rPr>
              <a:t>part in an audit of the programme </a:t>
            </a:r>
            <a:br>
              <a:rPr sz="1600"/>
            </a:b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327d"/>
                </a:solidFill>
                <a:latin typeface="Arial"/>
              </a:rPr>
              <a:t>966 outpatients (average age 46.6 years) with SMI &gt;2 years; </a:t>
            </a:r>
            <a:br>
              <a:rPr sz="1600"/>
            </a:br>
            <a:r>
              <a:rPr b="0" lang="en-GB" sz="1600" spc="-1" strike="noStrike">
                <a:solidFill>
                  <a:srgbClr val="00327d"/>
                </a:solidFill>
                <a:latin typeface="Arial"/>
              </a:rPr>
              <a:t>51% male and 49% female</a:t>
            </a:r>
            <a:br>
              <a:rPr sz="1600"/>
            </a:b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327d"/>
                </a:solidFill>
                <a:latin typeface="Arial"/>
              </a:rPr>
              <a:t>Patients enrolled to improve their physical health through: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 lvl="1" marL="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1f6347"/>
                </a:solidFill>
                <a:latin typeface="Arial"/>
              </a:rPr>
              <a:t>basic physical health checks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 lvl="1" marL="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1f6347"/>
                </a:solidFill>
                <a:latin typeface="Arial"/>
              </a:rPr>
              <a:t>weight management 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 lvl="1" marL="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1f6347"/>
                </a:solidFill>
                <a:latin typeface="Arial"/>
              </a:rPr>
              <a:t>physical activity groups 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 lvl="1" marL="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1f6347"/>
                </a:solidFill>
                <a:latin typeface="Arial"/>
              </a:rPr>
              <a:t>basic health promotion advice</a:t>
            </a:r>
            <a:r>
              <a:rPr b="1" lang="en-GB" sz="1600" spc="-1" strike="noStrike">
                <a:solidFill>
                  <a:srgbClr val="000000"/>
                </a:solidFill>
                <a:latin typeface="Arial"/>
              </a:rPr>
              <a:t>  . Only 31% had previous regular physical health checks ( range 7-49%) amongst the 7 UK trusts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"/>
          <p:cNvSpPr/>
          <p:nvPr/>
        </p:nvSpPr>
        <p:spPr>
          <a:xfrm>
            <a:off x="755640" y="4508640"/>
            <a:ext cx="7777080" cy="2167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00327d"/>
                </a:solidFill>
                <a:latin typeface="Arial"/>
              </a:rPr>
              <a:t>Random glucose measures</a:t>
            </a:r>
            <a:r>
              <a:rPr b="0" lang="en-GB" sz="1600" spc="-1" strike="noStrike">
                <a:solidFill>
                  <a:srgbClr val="00327d"/>
                </a:solidFill>
                <a:latin typeface="Arial"/>
              </a:rPr>
              <a:t> showed that: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 lvl="1" marL="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1f6347"/>
                </a:solidFill>
                <a:latin typeface="Arial"/>
              </a:rPr>
              <a:t>12.4% of the sample had a blood glucose &gt;7.1 mmol/l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 lvl="1" marL="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1f6347"/>
                </a:solidFill>
                <a:latin typeface="Arial"/>
              </a:rPr>
              <a:t>5.5% of the sample had blood glucose &gt;11mmol/l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 lvl="1" marL="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1f6347"/>
                </a:solidFill>
                <a:latin typeface="Arial"/>
              </a:rPr>
              <a:t>Mean HbA1c was 5.7 (35.7% had an HbA1c &gt; 5.7)</a:t>
            </a:r>
            <a:br>
              <a:rPr sz="1600"/>
            </a:b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00327d"/>
                </a:solidFill>
                <a:latin typeface="Arial"/>
              </a:rPr>
              <a:t>Lipid levels</a:t>
            </a:r>
            <a:r>
              <a:rPr b="0" lang="en-GB" sz="1600" spc="-1" strike="noStrike">
                <a:solidFill>
                  <a:srgbClr val="00327d"/>
                </a:solidFill>
                <a:latin typeface="Arial"/>
              </a:rPr>
              <a:t>: 71% had abnormal lipids  :31.6% were </a:t>
            </a:r>
            <a:r>
              <a:rPr b="1" lang="en-GB" sz="1600" spc="-1" strike="noStrike">
                <a:solidFill>
                  <a:srgbClr val="00327d"/>
                </a:solidFill>
                <a:latin typeface="Arial"/>
              </a:rPr>
              <a:t>hyperprolactinaemic</a:t>
            </a:r>
            <a:br>
              <a:rPr sz="1600"/>
            </a:br>
            <a:r>
              <a:rPr b="0" lang="en-GB" sz="1600" spc="-1" strike="noStrike">
                <a:solidFill>
                  <a:srgbClr val="00327d"/>
                </a:solidFill>
                <a:latin typeface="Arial"/>
              </a:rPr>
              <a:t>50.0% had </a:t>
            </a:r>
            <a:r>
              <a:rPr b="1" lang="en-GB" sz="1600" spc="-1" strike="noStrike">
                <a:solidFill>
                  <a:srgbClr val="00327d"/>
                </a:solidFill>
                <a:latin typeface="Arial"/>
              </a:rPr>
              <a:t>abnormal liver enzymes</a:t>
            </a:r>
            <a:r>
              <a:rPr b="0" lang="en-US" sz="1600" spc="-1" strike="noStrike">
                <a:solidFill>
                  <a:srgbClr val="00327d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graphicFrame>
        <p:nvGraphicFramePr>
          <p:cNvPr id="100" name=""/>
          <p:cNvGraphicFramePr/>
          <p:nvPr/>
        </p:nvGraphicFramePr>
        <p:xfrm>
          <a:off x="6516720" y="1773360"/>
          <a:ext cx="2627280" cy="216036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101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6516720" y="1773360"/>
                    <a:ext cx="2627280" cy="2160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International Journal of Clinical Practice  www.ijcp.org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1E1A0D-00D3-47D5-AA13-27C20D01057C}" type="slidenum">
              <a:t>2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"/>
          <p:cNvSpPr/>
          <p:nvPr/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marL="343080" indent="-343080">
              <a:lnSpc>
                <a:spcPct val="90000"/>
              </a:lnSpc>
              <a:spcBef>
                <a:spcPts val="476"/>
              </a:spcBef>
              <a:spcAft>
                <a:spcPts val="587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Nurse-led care delivery system:</a:t>
            </a:r>
            <a:endParaRPr b="0" lang="en-US" sz="19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lnSpc>
                <a:spcPct val="90000"/>
              </a:lnSpc>
              <a:spcBef>
                <a:spcPts val="476"/>
              </a:spcBef>
              <a:spcAft>
                <a:spcPts val="587"/>
              </a:spcAft>
              <a:buClr>
                <a:srgbClr val="000000"/>
              </a:buClr>
              <a:buSzPct val="120000"/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Lifestyle advice/education provided to motivate patients </a:t>
            </a:r>
            <a:br>
              <a:rPr sz="1900"/>
            </a:b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to improve lifestyle choices</a:t>
            </a:r>
            <a:br>
              <a:rPr sz="1900"/>
            </a:b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9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lnSpc>
                <a:spcPct val="90000"/>
              </a:lnSpc>
              <a:spcBef>
                <a:spcPts val="476"/>
              </a:spcBef>
              <a:spcAft>
                <a:spcPts val="587"/>
              </a:spcAft>
              <a:buClr>
                <a:srgbClr val="000000"/>
              </a:buClr>
              <a:buSzPct val="120000"/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Assessment of medication side-effects</a:t>
            </a:r>
            <a:br>
              <a:rPr sz="1900"/>
            </a:b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9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lnSpc>
                <a:spcPct val="90000"/>
              </a:lnSpc>
              <a:spcBef>
                <a:spcPts val="476"/>
              </a:spcBef>
              <a:spcAft>
                <a:spcPts val="587"/>
              </a:spcAft>
              <a:buClr>
                <a:srgbClr val="000000"/>
              </a:buClr>
              <a:buSzPct val="120000"/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Identification of physical problems</a:t>
            </a:r>
            <a:br>
              <a:rPr sz="1900"/>
            </a:b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9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lnSpc>
                <a:spcPct val="90000"/>
              </a:lnSpc>
              <a:spcBef>
                <a:spcPts val="476"/>
              </a:spcBef>
              <a:spcAft>
                <a:spcPts val="587"/>
              </a:spcAft>
              <a:buClr>
                <a:srgbClr val="000000"/>
              </a:buClr>
              <a:buSzPct val="120000"/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Initiation of physical health treatment and monitoring </a:t>
            </a:r>
            <a:br>
              <a:rPr sz="1900"/>
            </a:b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by prompt referral</a:t>
            </a:r>
            <a:br>
              <a:rPr sz="1900"/>
            </a:b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9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lnSpc>
                <a:spcPct val="90000"/>
              </a:lnSpc>
              <a:spcBef>
                <a:spcPts val="425"/>
              </a:spcBef>
              <a:spcAft>
                <a:spcPts val="524"/>
              </a:spcAft>
              <a:buClr>
                <a:srgbClr val="000000"/>
              </a:buClr>
              <a:buSzPct val="120000"/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Long-term intervention</a:t>
            </a: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"/>
          <p:cNvSpPr/>
          <p:nvPr/>
        </p:nvSpPr>
        <p:spPr>
          <a:xfrm>
            <a:off x="457200" y="343080"/>
            <a:ext cx="82296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e80000"/>
                </a:solidFill>
                <a:latin typeface="Tahoma"/>
              </a:rPr>
              <a:t>Approach of </a:t>
            </a:r>
            <a:r>
              <a:rPr b="1" lang="en-GB" sz="2400" spc="-1" strike="noStrike">
                <a:solidFill>
                  <a:srgbClr val="e80000"/>
                </a:solidFill>
                <a:latin typeface="Tahoma"/>
              </a:rPr>
              <a:t>Wellbeing Support Programme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International Journal of Clinical Practice  www.ijcp.org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F0CA98-15B5-477A-A204-303C0A296CDC}" type="slidenum">
              <a:t>3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clickEffect" fill="hold" presetClass="entr" presetID="22" presetSubtype="8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2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wipe(left)" transition="in">
                                      <p:cBhvr additive="repl">
                                        <p:cTn id="7" dur="500"/>
                                        <p:tgtEl>
                                          <p:spTgt spid="102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nodeType="withEffect" fill="hold" presetClass="entr" presetID="22" presetSubtype="8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2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wipe(left)" transition="in">
                                      <p:cBhvr additive="repl">
                                        <p:cTn id="10" dur="500"/>
                                        <p:tgtEl>
                                          <p:spTgt spid="102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1" nodeType="withEffect" fill="hold" presetClass="entr" presetID="22" presetSubtype="8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2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wipe(left)" transition="in">
                                      <p:cBhvr additive="repl">
                                        <p:cTn id="13" dur="500"/>
                                        <p:tgtEl>
                                          <p:spTgt spid="102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4" nodeType="withEffect" fill="hold" presetClass="entr" presetID="22" presetSubtype="8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2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wipe(left)" transition="in">
                                      <p:cBhvr additive="repl">
                                        <p:cTn id="16" dur="500"/>
                                        <p:tgtEl>
                                          <p:spTgt spid="102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7" nodeType="withEffect" fill="hold" presetClass="entr" presetID="22" presetSubtype="8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2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wipe(left)" transition="in">
                                      <p:cBhvr additive="repl">
                                        <p:cTn id="19" dur="500"/>
                                        <p:tgtEl>
                                          <p:spTgt spid="102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600120" y="-360"/>
            <a:ext cx="6996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e80000"/>
                </a:solidFill>
                <a:latin typeface="Tahoma"/>
              </a:rPr>
              <a:t>Baseline WSP Findings</a:t>
            </a: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105" name="PlaceHolder 2"/>
          <p:cNvSpPr>
            <a:spLocks noGrp="1"/>
          </p:cNvSpPr>
          <p:nvPr>
            <p:ph/>
          </p:nvPr>
        </p:nvSpPr>
        <p:spPr>
          <a:xfrm>
            <a:off x="627120" y="1442880"/>
            <a:ext cx="3230640" cy="475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60360" indent="-360360">
              <a:lnSpc>
                <a:spcPct val="85000"/>
              </a:lnSpc>
              <a:spcBef>
                <a:spcPts val="349"/>
              </a:spcBef>
              <a:spcAft>
                <a:spcPts val="437"/>
              </a:spcAft>
              <a:buClr>
                <a:srgbClr val="e80000"/>
              </a:buClr>
              <a:buSzPct val="120000"/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The baseline physical health checks uncovered a </a:t>
            </a: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high prevalence </a:t>
            </a:r>
            <a:br>
              <a:rPr sz="1400"/>
            </a:b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of baseline physical illness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 among the WSP cohort and a </a:t>
            </a: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low </a:t>
            </a:r>
            <a:br>
              <a:rPr sz="1400"/>
            </a:b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level of prior physical health check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60360" indent="-360360">
              <a:lnSpc>
                <a:spcPct val="85000"/>
              </a:lnSpc>
              <a:spcBef>
                <a:spcPts val="349"/>
              </a:spcBef>
              <a:spcAft>
                <a:spcPts val="437"/>
              </a:spcAft>
              <a:buClr>
                <a:srgbClr val="e80000"/>
              </a:buClr>
              <a:buSzPct val="120000"/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Identified 34 study participants (3.5%) requiring urgent referral for potentially life-threatening condition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60360" indent="-360360">
              <a:lnSpc>
                <a:spcPct val="85000"/>
              </a:lnSpc>
              <a:spcBef>
                <a:spcPts val="349"/>
              </a:spcBef>
              <a:spcAft>
                <a:spcPts val="437"/>
              </a:spcAft>
              <a:buClr>
                <a:srgbClr val="e80000"/>
              </a:buClr>
              <a:buSzPct val="120000"/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Physical health problems included: obesity, elevated blood pressure, dyslipidaemia, diabetes, hyperprolactinaemia, liver function abnormalit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60360" indent="-360360">
              <a:lnSpc>
                <a:spcPct val="85000"/>
              </a:lnSpc>
              <a:spcBef>
                <a:spcPts val="349"/>
              </a:spcBef>
              <a:spcAft>
                <a:spcPts val="437"/>
              </a:spcAft>
              <a:buClr>
                <a:srgbClr val="e80000"/>
              </a:buClr>
              <a:buSzPct val="120000"/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These health problems were compounded by the poor standards </a:t>
            </a:r>
            <a:br>
              <a:rPr sz="1400"/>
            </a:b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of livin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60360" indent="-360360">
              <a:lnSpc>
                <a:spcPct val="85000"/>
              </a:lnSpc>
              <a:spcBef>
                <a:spcPts val="349"/>
              </a:spcBef>
              <a:spcAft>
                <a:spcPts val="437"/>
              </a:spcAft>
              <a:buClr>
                <a:srgbClr val="e80000"/>
              </a:buClr>
              <a:buSzPct val="120000"/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ardiovascular risk factors were highly prevalen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60360" indent="0">
              <a:lnSpc>
                <a:spcPct val="85000"/>
              </a:lnSpc>
              <a:spcBef>
                <a:spcPts val="349"/>
              </a:spcBef>
              <a:spcAft>
                <a:spcPts val="43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06" name=""/>
          <p:cNvGraphicFramePr/>
          <p:nvPr/>
        </p:nvGraphicFramePr>
        <p:xfrm>
          <a:off x="4010040" y="1916280"/>
          <a:ext cx="4665600" cy="417672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107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010040" y="1916280"/>
                    <a:ext cx="4665600" cy="4176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08" name=""/>
          <p:cNvSpPr/>
          <p:nvPr/>
        </p:nvSpPr>
        <p:spPr>
          <a:xfrm>
            <a:off x="9972720" y="2276640"/>
            <a:ext cx="46623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International Journal of Clinical Practice  www.ijcp.org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E4A632-356A-4D97-BBAD-B6DA5DD06401}" type="slidenum">
              <a:t>4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e80000"/>
                </a:solidFill>
                <a:latin typeface="Tahoma"/>
              </a:rPr>
              <a:t>Blood Pressure Abnormal Findings ( BHS 2004 guidelines)</a:t>
            </a: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graphicFrame>
        <p:nvGraphicFramePr>
          <p:cNvPr id="110" name=""/>
          <p:cNvGraphicFramePr/>
          <p:nvPr/>
        </p:nvGraphicFramePr>
        <p:xfrm>
          <a:off x="627120" y="1782720"/>
          <a:ext cx="6613560" cy="407520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111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627120" y="1782720"/>
                    <a:ext cx="6613560" cy="4075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International Journal of Clinical Practice  www.ijcp.org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3585AA-D5CB-4CAD-B0D4-B283BCCA2885}" type="slidenum">
              <a:t>5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e80000"/>
                </a:solidFill>
                <a:latin typeface="Tahoma"/>
              </a:rPr>
              <a:t>BMI Categories at Baseline</a:t>
            </a: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graphicFrame>
        <p:nvGraphicFramePr>
          <p:cNvPr id="113" name=""/>
          <p:cNvGraphicFramePr/>
          <p:nvPr/>
        </p:nvGraphicFramePr>
        <p:xfrm>
          <a:off x="627120" y="1844640"/>
          <a:ext cx="4521240" cy="320364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114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627120" y="1844640"/>
                    <a:ext cx="4521240" cy="3203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15" name=""/>
          <p:cNvGraphicFramePr/>
          <p:nvPr/>
        </p:nvGraphicFramePr>
        <p:xfrm>
          <a:off x="5796000" y="3716280"/>
          <a:ext cx="2663280" cy="2481120"/>
        </p:xfrm>
        <a:graphic>
          <a:graphicData uri="http://schemas.openxmlformats.org/drawingml/2006/table">
            <a:tbl>
              <a:tblPr/>
              <a:tblGrid>
                <a:gridCol w="1785240"/>
                <a:gridCol w="878040"/>
              </a:tblGrid>
              <a:tr h="59004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5000"/>
                        </a:lnSpc>
                        <a:spcBef>
                          <a:spcPts val="249"/>
                        </a:spcBef>
                        <a:spcAft>
                          <a:spcPts val="312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ffcc00"/>
                          </a:solidFill>
                          <a:latin typeface="Arial"/>
                        </a:rPr>
                        <a:t>	</a:t>
                      </a:r>
                      <a:r>
                        <a:rPr b="0" lang="en-US" sz="1000" spc="-1" strike="noStrike">
                          <a:solidFill>
                            <a:srgbClr val="ffcc00"/>
                          </a:solidFill>
                          <a:latin typeface="Arial"/>
                        </a:rPr>
                        <a:t>	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3535a1"/>
                      </a:solidFill>
                    </a:lnR>
                    <a:lnT>
                      <a:noFill/>
                    </a:lnT>
                    <a:lnB w="5760">
                      <a:solidFill>
                        <a:srgbClr val="3535a1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5000"/>
                        </a:lnSpc>
                        <a:spcBef>
                          <a:spcPts val="249"/>
                        </a:spcBef>
                        <a:spcAft>
                          <a:spcPts val="312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BMI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ctr" marL="90000" marR="90000">
                    <a:lnL w="5760">
                      <a:solidFill>
                        <a:srgbClr val="3535a1"/>
                      </a:solidFill>
                    </a:lnL>
                    <a:lnR w="5760">
                      <a:solidFill>
                        <a:srgbClr val="3535a1"/>
                      </a:solidFill>
                    </a:lnR>
                    <a:lnT w="5760">
                      <a:solidFill>
                        <a:srgbClr val="3535a1"/>
                      </a:solidFill>
                    </a:lnT>
                    <a:lnB w="5760">
                      <a:solidFill>
                        <a:srgbClr val="3535a1"/>
                      </a:solidFill>
                    </a:lnB>
                    <a:solidFill>
                      <a:srgbClr val="1f6347"/>
                    </a:solidFill>
                  </a:tcPr>
                </a:tc>
              </a:tr>
              <a:tr h="37800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5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1f6347"/>
                          </a:solidFill>
                          <a:latin typeface="Arial"/>
                        </a:rPr>
                        <a:t>Underweigh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ctr" marL="90000" marR="90000">
                    <a:lnL w="5760">
                      <a:solidFill>
                        <a:srgbClr val="3535a1"/>
                      </a:solidFill>
                    </a:lnL>
                    <a:lnR w="5760">
                      <a:solidFill>
                        <a:srgbClr val="3535a1"/>
                      </a:solidFill>
                    </a:lnR>
                    <a:lnT w="5760">
                      <a:solidFill>
                        <a:srgbClr val="3535a1"/>
                      </a:solidFill>
                    </a:lnT>
                    <a:lnB w="5760">
                      <a:solidFill>
                        <a:srgbClr val="3535a1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5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&lt;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ctr" marL="90000" marR="90000">
                    <a:lnL w="5760">
                      <a:solidFill>
                        <a:srgbClr val="3535a1"/>
                      </a:solidFill>
                    </a:lnL>
                    <a:lnR w="5760">
                      <a:solidFill>
                        <a:srgbClr val="3535a1"/>
                      </a:solidFill>
                    </a:lnR>
                    <a:lnT w="5760">
                      <a:solidFill>
                        <a:srgbClr val="3535a1"/>
                      </a:solidFill>
                    </a:lnT>
                    <a:lnB w="5760">
                      <a:solidFill>
                        <a:srgbClr val="3535a1"/>
                      </a:solidFill>
                    </a:lnB>
                    <a:noFill/>
                  </a:tcPr>
                </a:tc>
              </a:tr>
              <a:tr h="37800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5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1f6347"/>
                          </a:solidFill>
                          <a:latin typeface="Arial"/>
                        </a:rPr>
                        <a:t>Norma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ctr" marL="90000" marR="90000">
                    <a:lnL w="5760">
                      <a:solidFill>
                        <a:srgbClr val="3535a1"/>
                      </a:solidFill>
                    </a:lnL>
                    <a:lnR w="5760">
                      <a:solidFill>
                        <a:srgbClr val="3535a1"/>
                      </a:solidFill>
                    </a:lnR>
                    <a:lnT w="5760">
                      <a:solidFill>
                        <a:srgbClr val="3535a1"/>
                      </a:solidFill>
                    </a:lnT>
                    <a:lnB w="5760">
                      <a:solidFill>
                        <a:srgbClr val="3535a1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5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8-2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ctr" marL="90000" marR="90000">
                    <a:lnL w="5760">
                      <a:solidFill>
                        <a:srgbClr val="3535a1"/>
                      </a:solidFill>
                    </a:lnL>
                    <a:lnR w="5760">
                      <a:solidFill>
                        <a:srgbClr val="3535a1"/>
                      </a:solidFill>
                    </a:lnR>
                    <a:lnT w="5760">
                      <a:solidFill>
                        <a:srgbClr val="3535a1"/>
                      </a:solidFill>
                    </a:lnT>
                    <a:lnB w="5760">
                      <a:solidFill>
                        <a:srgbClr val="3535a1"/>
                      </a:solidFill>
                    </a:lnB>
                    <a:noFill/>
                  </a:tcPr>
                </a:tc>
              </a:tr>
              <a:tr h="37872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5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1f6347"/>
                          </a:solidFill>
                          <a:latin typeface="Arial"/>
                        </a:rPr>
                        <a:t>Overweigh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ctr" marL="90000" marR="90000">
                    <a:lnL w="5760">
                      <a:solidFill>
                        <a:srgbClr val="3535a1"/>
                      </a:solidFill>
                    </a:lnL>
                    <a:lnR w="5760">
                      <a:solidFill>
                        <a:srgbClr val="3535a1"/>
                      </a:solidFill>
                    </a:lnR>
                    <a:lnT w="5760">
                      <a:solidFill>
                        <a:srgbClr val="3535a1"/>
                      </a:solidFill>
                    </a:lnT>
                    <a:lnB w="5760">
                      <a:solidFill>
                        <a:srgbClr val="3535a1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5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6-3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ctr" marL="90000" marR="90000">
                    <a:lnL w="5760">
                      <a:solidFill>
                        <a:srgbClr val="3535a1"/>
                      </a:solidFill>
                    </a:lnL>
                    <a:lnR w="5760">
                      <a:solidFill>
                        <a:srgbClr val="3535a1"/>
                      </a:solidFill>
                    </a:lnR>
                    <a:lnT w="5760">
                      <a:solidFill>
                        <a:srgbClr val="3535a1"/>
                      </a:solidFill>
                    </a:lnT>
                    <a:lnB w="5760">
                      <a:solidFill>
                        <a:srgbClr val="3535a1"/>
                      </a:solidFill>
                    </a:lnB>
                    <a:noFill/>
                  </a:tcPr>
                </a:tc>
              </a:tr>
              <a:tr h="37800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5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1f6347"/>
                          </a:solidFill>
                          <a:latin typeface="Arial"/>
                        </a:rPr>
                        <a:t>Obese (class 1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ctr" marL="90000" marR="90000">
                    <a:lnL w="5760">
                      <a:solidFill>
                        <a:srgbClr val="3535a1"/>
                      </a:solidFill>
                    </a:lnL>
                    <a:lnR w="5760">
                      <a:solidFill>
                        <a:srgbClr val="3535a1"/>
                      </a:solidFill>
                    </a:lnR>
                    <a:lnT w="5760">
                      <a:solidFill>
                        <a:srgbClr val="3535a1"/>
                      </a:solidFill>
                    </a:lnT>
                    <a:lnB w="5760">
                      <a:solidFill>
                        <a:srgbClr val="3535a1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5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1-3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ctr" marL="90000" marR="90000">
                    <a:lnL w="5760">
                      <a:solidFill>
                        <a:srgbClr val="3535a1"/>
                      </a:solidFill>
                    </a:lnL>
                    <a:lnR w="5760">
                      <a:solidFill>
                        <a:srgbClr val="3535a1"/>
                      </a:solidFill>
                    </a:lnR>
                    <a:lnT w="5760">
                      <a:solidFill>
                        <a:srgbClr val="3535a1"/>
                      </a:solidFill>
                    </a:lnT>
                    <a:lnB w="5760">
                      <a:solidFill>
                        <a:srgbClr val="3535a1"/>
                      </a:solidFill>
                    </a:lnB>
                    <a:noFill/>
                  </a:tcPr>
                </a:tc>
              </a:tr>
              <a:tr h="37836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5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1f6347"/>
                          </a:solidFill>
                          <a:latin typeface="Arial"/>
                        </a:rPr>
                        <a:t>Obese (class 2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ctr" marL="90000" marR="90000">
                    <a:lnL w="5760">
                      <a:solidFill>
                        <a:srgbClr val="3535a1"/>
                      </a:solidFill>
                    </a:lnL>
                    <a:lnR w="5760">
                      <a:solidFill>
                        <a:srgbClr val="3535a1"/>
                      </a:solidFill>
                    </a:lnR>
                    <a:lnT w="5760">
                      <a:solidFill>
                        <a:srgbClr val="3535a1"/>
                      </a:solidFill>
                    </a:lnT>
                    <a:lnB w="5760">
                      <a:solidFill>
                        <a:srgbClr val="3535a1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5000"/>
                        </a:lnSpc>
                        <a:spcBef>
                          <a:spcPts val="125"/>
                        </a:spcBef>
                        <a:spcAft>
                          <a:spcPts val="125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&gt;3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ctr" marL="90000" marR="90000">
                    <a:lnL w="5760">
                      <a:solidFill>
                        <a:srgbClr val="3535a1"/>
                      </a:solidFill>
                    </a:lnL>
                    <a:lnR w="5760">
                      <a:solidFill>
                        <a:srgbClr val="3535a1"/>
                      </a:solidFill>
                    </a:lnR>
                    <a:lnT w="5760">
                      <a:solidFill>
                        <a:srgbClr val="3535a1"/>
                      </a:solidFill>
                    </a:lnT>
                    <a:lnB w="5760">
                      <a:solidFill>
                        <a:srgbClr val="3535a1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International Journal of Clinical Practice  www.ijcp.org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CD66E2-7053-44D9-921E-F4FFE1F16A69}" type="slidenum">
              <a:t>6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6" name=""/>
          <p:cNvGraphicFramePr/>
          <p:nvPr/>
        </p:nvGraphicFramePr>
        <p:xfrm>
          <a:off x="-709560" y="1897200"/>
          <a:ext cx="5116320" cy="354312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117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-709560" y="1897200"/>
                    <a:ext cx="5116320" cy="3543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18" name=""/>
          <p:cNvGraphicFramePr/>
          <p:nvPr/>
        </p:nvGraphicFramePr>
        <p:xfrm>
          <a:off x="3492360" y="2036880"/>
          <a:ext cx="6046920" cy="369252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119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492360" y="2036880"/>
                    <a:ext cx="6046920" cy="3692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20" name=""/>
          <p:cNvSpPr/>
          <p:nvPr/>
        </p:nvSpPr>
        <p:spPr>
          <a:xfrm>
            <a:off x="457200" y="343080"/>
            <a:ext cx="82296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e80000"/>
                </a:solidFill>
                <a:latin typeface="Tahoma"/>
              </a:rPr>
              <a:t>Baseline: diet and self-esteem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International Journal of Clinical Practice  www.ijcp.org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514FB4-0664-4B1C-BB97-0F0D65C11A10}" type="slidenum">
              <a:t>7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20" dur="indefinite" restart="never" nodeType="tmRoot">
          <p:childTnLst>
            <p:seq>
              <p:cTn id="21" dur="indefinite" nodeType="mainSeq">
                <p:childTnLst>
                  <p:par>
                    <p:cTn id="22" fill="hold">
                      <p:stCondLst>
                        <p:cond delay="indefinite"/>
                      </p:stCondLst>
                      <p:childTnLst>
                        <p:par>
                          <p:cTn id="23" fill="hold">
                            <p:stCondLst>
                              <p:cond delay="0"/>
                            </p:stCondLst>
                            <p:childTnLst>
                              <p:par>
                                <p:cTn id="24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1" name="" descr=""/>
          <p:cNvPicPr/>
          <p:nvPr/>
        </p:nvPicPr>
        <p:blipFill>
          <a:blip r:embed="rId1"/>
          <a:stretch/>
        </p:blipFill>
        <p:spPr>
          <a:xfrm>
            <a:off x="626760" y="1442880"/>
            <a:ext cx="6613560" cy="4754880"/>
          </a:xfrm>
          <a:prstGeom prst="rect">
            <a:avLst/>
          </a:prstGeom>
          <a:ln w="0">
            <a:noFill/>
          </a:ln>
        </p:spPr>
      </p:pic>
      <p:sp>
        <p:nvSpPr>
          <p:cNvPr id="122" name=""/>
          <p:cNvSpPr/>
          <p:nvPr/>
        </p:nvSpPr>
        <p:spPr>
          <a:xfrm>
            <a:off x="457200" y="5075280"/>
            <a:ext cx="8229600" cy="806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5000"/>
              </a:lnSpc>
              <a:spcBef>
                <a:spcPts val="425"/>
              </a:spcBef>
              <a:spcAft>
                <a:spcPts val="52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700" spc="-1" strike="noStrike">
                <a:solidFill>
                  <a:srgbClr val="000000"/>
                </a:solidFill>
                <a:latin typeface="Arial"/>
              </a:rPr>
              <a:t>Conclusion:</a:t>
            </a:r>
            <a:r>
              <a:rPr b="0" lang="en-GB" sz="1700" spc="-1" strike="noStrike">
                <a:solidFill>
                  <a:srgbClr val="000000"/>
                </a:solidFill>
                <a:latin typeface="Arial"/>
              </a:rPr>
              <a:t> increased activity is related to lower blood </a:t>
            </a:r>
            <a:br>
              <a:rPr sz="1700"/>
            </a:br>
            <a:r>
              <a:rPr b="0" lang="en-GB" sz="1700" spc="-1" strike="noStrike">
                <a:solidFill>
                  <a:srgbClr val="000000"/>
                </a:solidFill>
                <a:latin typeface="Arial"/>
              </a:rPr>
              <a:t>pressure, lower heart rate, better diets</a:t>
            </a:r>
            <a:endParaRPr b="0" lang="en-US" sz="1700" spc="-1" strike="noStrike">
              <a:solidFill>
                <a:srgbClr val="000000"/>
              </a:solidFill>
              <a:latin typeface="Times New Roman"/>
            </a:endParaRPr>
          </a:p>
        </p:txBody>
      </p:sp>
      <p:graphicFrame>
        <p:nvGraphicFramePr>
          <p:cNvPr id="123" name=""/>
          <p:cNvGraphicFramePr/>
          <p:nvPr/>
        </p:nvGraphicFramePr>
        <p:xfrm>
          <a:off x="819000" y="1752480"/>
          <a:ext cx="7270920" cy="2562480"/>
        </p:xfrm>
        <a:graphic>
          <a:graphicData uri="http://schemas.openxmlformats.org/drawingml/2006/table">
            <a:tbl>
              <a:tblPr/>
              <a:tblGrid>
                <a:gridCol w="3046680"/>
                <a:gridCol w="2171520"/>
                <a:gridCol w="2052720"/>
              </a:tblGrid>
              <a:tr h="62712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5000"/>
                        </a:lnSpc>
                        <a:spcBef>
                          <a:spcPts val="425"/>
                        </a:spcBef>
                        <a:spcAft>
                          <a:spcPts val="524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ffcc00"/>
                          </a:solidFill>
                          <a:latin typeface="Arial"/>
                        </a:rPr>
                        <a:t>	</a:t>
                      </a:r>
                      <a:r>
                        <a:rPr b="0" lang="en-US" sz="1700" spc="-1" strike="noStrike">
                          <a:solidFill>
                            <a:srgbClr val="ffcc00"/>
                          </a:solidFill>
                          <a:latin typeface="Arial"/>
                        </a:rPr>
                        <a:t>	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13680">
                      <a:solidFill>
                        <a:srgbClr val="333333"/>
                      </a:solidFill>
                    </a:lnR>
                    <a:lnT>
                      <a:noFill/>
                    </a:lnT>
                    <a:lnB w="13680">
                      <a:solidFill>
                        <a:srgbClr val="333333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5000"/>
                        </a:lnSpc>
                        <a:spcBef>
                          <a:spcPts val="425"/>
                        </a:spcBef>
                        <a:spcAft>
                          <a:spcPts val="524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700" spc="-1" strike="noStrike">
                          <a:solidFill>
                            <a:srgbClr val="1f6347"/>
                          </a:solidFill>
                          <a:latin typeface="Arial"/>
                        </a:rPr>
                        <a:t>Correlation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ctr" marL="90000" marR="90000">
                    <a:lnL w="13680">
                      <a:solidFill>
                        <a:srgbClr val="333333"/>
                      </a:solidFill>
                    </a:lnL>
                    <a:lnR w="13680">
                      <a:solidFill>
                        <a:srgbClr val="333333"/>
                      </a:solidFill>
                    </a:lnR>
                    <a:lnT w="13680">
                      <a:solidFill>
                        <a:srgbClr val="333333"/>
                      </a:solidFill>
                    </a:lnT>
                    <a:lnB w="13680">
                      <a:solidFill>
                        <a:srgbClr val="333333"/>
                      </a:solidFill>
                    </a:lnB>
                    <a:solidFill>
                      <a:srgbClr val="ec0000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700" spc="-1" strike="noStrike">
                          <a:solidFill>
                            <a:srgbClr val="1f6347"/>
                          </a:solidFill>
                          <a:latin typeface="Arial"/>
                        </a:rPr>
                        <a:t>(r=X; </a:t>
                      </a:r>
                      <a:r>
                        <a:rPr b="0" i="1" lang="en-GB" sz="1700" spc="-1" strike="noStrike">
                          <a:solidFill>
                            <a:srgbClr val="1f6347"/>
                          </a:solidFill>
                          <a:latin typeface="Arial"/>
                        </a:rPr>
                        <a:t>p</a:t>
                      </a:r>
                      <a:r>
                        <a:rPr b="1" lang="en-GB" sz="1700" spc="-1" strike="noStrike">
                          <a:solidFill>
                            <a:srgbClr val="1f6347"/>
                          </a:solidFill>
                          <a:latin typeface="Arial"/>
                        </a:rPr>
                        <a:t>&lt;Y)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ctr" marL="90000" marR="90000">
                    <a:lnL w="13680">
                      <a:solidFill>
                        <a:srgbClr val="333333"/>
                      </a:solidFill>
                    </a:lnL>
                    <a:lnR w="13680">
                      <a:solidFill>
                        <a:srgbClr val="333333"/>
                      </a:solidFill>
                    </a:lnR>
                    <a:lnT w="13680">
                      <a:solidFill>
                        <a:srgbClr val="333333"/>
                      </a:solidFill>
                    </a:lnT>
                    <a:lnB w="13680">
                      <a:solidFill>
                        <a:srgbClr val="333333"/>
                      </a:solidFill>
                    </a:lnB>
                    <a:solidFill>
                      <a:srgbClr val="ec0000"/>
                    </a:solidFill>
                  </a:tcPr>
                </a:tc>
              </a:tr>
              <a:tr h="70020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5000"/>
                        </a:lnSpc>
                        <a:spcBef>
                          <a:spcPts val="187"/>
                        </a:spcBef>
                        <a:spcAft>
                          <a:spcPts val="187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500" spc="-1" strike="noStrike">
                          <a:solidFill>
                            <a:srgbClr val="1f6347"/>
                          </a:solidFill>
                          <a:latin typeface="Arial"/>
                        </a:rPr>
                        <a:t>Quality of diet</a:t>
                      </a:r>
                      <a:endParaRPr b="0" lang="en-US" sz="15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ctr" marL="90000" marR="90000">
                    <a:lnL w="13680">
                      <a:solidFill>
                        <a:srgbClr val="333333"/>
                      </a:solidFill>
                    </a:lnL>
                    <a:lnR w="13680">
                      <a:solidFill>
                        <a:srgbClr val="333333"/>
                      </a:solidFill>
                    </a:lnR>
                    <a:lnT w="13680">
                      <a:solidFill>
                        <a:srgbClr val="333333"/>
                      </a:solidFill>
                    </a:lnT>
                    <a:lnB w="13680">
                      <a:solidFill>
                        <a:srgbClr val="333333"/>
                      </a:solidFill>
                    </a:lnB>
                    <a:solidFill>
                      <a:srgbClr val="ec0000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5000"/>
                        </a:lnSpc>
                        <a:spcBef>
                          <a:spcPts val="162"/>
                        </a:spcBef>
                        <a:spcAft>
                          <a:spcPts val="162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ositive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ctr" marL="90000" marR="90000">
                    <a:lnL w="13680">
                      <a:solidFill>
                        <a:srgbClr val="333333"/>
                      </a:solidFill>
                    </a:lnL>
                    <a:lnR w="13680">
                      <a:solidFill>
                        <a:srgbClr val="1f6347"/>
                      </a:solidFill>
                    </a:lnR>
                    <a:lnT w="13680">
                      <a:solidFill>
                        <a:srgbClr val="333333"/>
                      </a:solidFill>
                    </a:lnT>
                    <a:lnB w="13680">
                      <a:solidFill>
                        <a:srgbClr val="1f6347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r=0.16, </a:t>
                      </a:r>
                      <a:r>
                        <a:rPr b="0" i="1" lang="en-GB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</a:t>
                      </a:r>
                      <a:r>
                        <a:rPr b="0" lang="en-GB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&lt;0.001)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ctr" marL="90000" marR="90000">
                    <a:lnL w="13680">
                      <a:solidFill>
                        <a:srgbClr val="1f6347"/>
                      </a:solidFill>
                    </a:lnL>
                    <a:lnR w="13680">
                      <a:solidFill>
                        <a:srgbClr val="1f6347"/>
                      </a:solidFill>
                    </a:lnR>
                    <a:lnT w="13680">
                      <a:solidFill>
                        <a:srgbClr val="333333"/>
                      </a:solidFill>
                    </a:lnT>
                    <a:lnB w="13680">
                      <a:solidFill>
                        <a:srgbClr val="1f6347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41112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5000"/>
                        </a:lnSpc>
                        <a:spcBef>
                          <a:spcPts val="187"/>
                        </a:spcBef>
                        <a:spcAft>
                          <a:spcPts val="187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500" spc="-1" strike="noStrike">
                          <a:solidFill>
                            <a:srgbClr val="1f6347"/>
                          </a:solidFill>
                          <a:latin typeface="Arial"/>
                        </a:rPr>
                        <a:t>DBP</a:t>
                      </a:r>
                      <a:endParaRPr b="0" lang="en-US" sz="15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ctr" marL="90000" marR="90000">
                    <a:lnL w="13680">
                      <a:solidFill>
                        <a:srgbClr val="333333"/>
                      </a:solidFill>
                    </a:lnL>
                    <a:lnR w="13680">
                      <a:solidFill>
                        <a:srgbClr val="333333"/>
                      </a:solidFill>
                    </a:lnR>
                    <a:lnT w="13680">
                      <a:solidFill>
                        <a:srgbClr val="333333"/>
                      </a:solidFill>
                    </a:lnT>
                    <a:lnB w="13680">
                      <a:solidFill>
                        <a:srgbClr val="333333"/>
                      </a:solidFill>
                    </a:lnB>
                    <a:solidFill>
                      <a:srgbClr val="ec0000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5000"/>
                        </a:lnSpc>
                        <a:spcBef>
                          <a:spcPts val="162"/>
                        </a:spcBef>
                        <a:spcAft>
                          <a:spcPts val="162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egative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ctr" marL="90000" marR="90000">
                    <a:lnL w="13680">
                      <a:solidFill>
                        <a:srgbClr val="333333"/>
                      </a:solidFill>
                    </a:lnL>
                    <a:lnR w="13680">
                      <a:solidFill>
                        <a:srgbClr val="1f6347"/>
                      </a:solidFill>
                    </a:lnR>
                    <a:lnT w="13680">
                      <a:solidFill>
                        <a:srgbClr val="1f6347"/>
                      </a:solidFill>
                    </a:lnT>
                    <a:lnB w="13680">
                      <a:solidFill>
                        <a:srgbClr val="1f6347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r=0.08, </a:t>
                      </a:r>
                      <a:r>
                        <a:rPr b="0" i="1" lang="en-GB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</a:t>
                      </a:r>
                      <a:r>
                        <a:rPr b="0" lang="en-GB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&lt;0.05)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ctr" marL="90000" marR="90000">
                    <a:lnL w="13680">
                      <a:solidFill>
                        <a:srgbClr val="1f6347"/>
                      </a:solidFill>
                    </a:lnL>
                    <a:lnR w="13680">
                      <a:solidFill>
                        <a:srgbClr val="1f6347"/>
                      </a:solidFill>
                    </a:lnR>
                    <a:lnT w="13680">
                      <a:solidFill>
                        <a:srgbClr val="1f6347"/>
                      </a:solidFill>
                    </a:lnT>
                    <a:lnB w="13680">
                      <a:solidFill>
                        <a:srgbClr val="1f6347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41292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5000"/>
                        </a:lnSpc>
                        <a:spcBef>
                          <a:spcPts val="187"/>
                        </a:spcBef>
                        <a:spcAft>
                          <a:spcPts val="187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500" spc="-1" strike="noStrike">
                          <a:solidFill>
                            <a:srgbClr val="1f6347"/>
                          </a:solidFill>
                          <a:latin typeface="Arial"/>
                        </a:rPr>
                        <a:t>Heart rate</a:t>
                      </a:r>
                      <a:endParaRPr b="0" lang="en-US" sz="15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ctr" marL="90000" marR="90000">
                    <a:lnL w="13680">
                      <a:solidFill>
                        <a:srgbClr val="333333"/>
                      </a:solidFill>
                    </a:lnL>
                    <a:lnR w="13680">
                      <a:solidFill>
                        <a:srgbClr val="333333"/>
                      </a:solidFill>
                    </a:lnR>
                    <a:lnT w="13680">
                      <a:solidFill>
                        <a:srgbClr val="333333"/>
                      </a:solidFill>
                    </a:lnT>
                    <a:lnB w="13680">
                      <a:solidFill>
                        <a:srgbClr val="333333"/>
                      </a:solidFill>
                    </a:lnB>
                    <a:solidFill>
                      <a:srgbClr val="ec0000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5000"/>
                        </a:lnSpc>
                        <a:spcBef>
                          <a:spcPts val="162"/>
                        </a:spcBef>
                        <a:spcAft>
                          <a:spcPts val="162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egative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ctr" marL="90000" marR="90000">
                    <a:lnL w="13680">
                      <a:solidFill>
                        <a:srgbClr val="333333"/>
                      </a:solidFill>
                    </a:lnL>
                    <a:lnR w="13680">
                      <a:solidFill>
                        <a:srgbClr val="1f6347"/>
                      </a:solidFill>
                    </a:lnR>
                    <a:lnT w="13680">
                      <a:solidFill>
                        <a:srgbClr val="1f6347"/>
                      </a:solidFill>
                    </a:lnT>
                    <a:lnB w="13680">
                      <a:solidFill>
                        <a:srgbClr val="1f6347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5000"/>
                        </a:lnSpc>
                        <a:spcBef>
                          <a:spcPts val="162"/>
                        </a:spcBef>
                        <a:spcAft>
                          <a:spcPts val="162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r=0.07, </a:t>
                      </a:r>
                      <a:r>
                        <a:rPr b="0" i="1" lang="en-GB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</a:t>
                      </a:r>
                      <a:r>
                        <a:rPr b="0" lang="en-GB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&lt;0.05)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ctr" marL="90000" marR="90000">
                    <a:lnL w="13680">
                      <a:solidFill>
                        <a:srgbClr val="1f6347"/>
                      </a:solidFill>
                    </a:lnL>
                    <a:lnR w="13680">
                      <a:solidFill>
                        <a:srgbClr val="1f6347"/>
                      </a:solidFill>
                    </a:lnR>
                    <a:lnT w="13680">
                      <a:solidFill>
                        <a:srgbClr val="1f6347"/>
                      </a:solidFill>
                    </a:lnT>
                    <a:lnB w="13680">
                      <a:solidFill>
                        <a:srgbClr val="1f6347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41112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5000"/>
                        </a:lnSpc>
                        <a:spcBef>
                          <a:spcPts val="187"/>
                        </a:spcBef>
                        <a:spcAft>
                          <a:spcPts val="187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500" spc="-1" strike="noStrike">
                          <a:solidFill>
                            <a:srgbClr val="1f6347"/>
                          </a:solidFill>
                          <a:latin typeface="Arial"/>
                        </a:rPr>
                        <a:t>Alcohol intake</a:t>
                      </a:r>
                      <a:endParaRPr b="0" lang="en-US" sz="15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ctr" marL="90000" marR="90000">
                    <a:lnL w="13680">
                      <a:solidFill>
                        <a:srgbClr val="333333"/>
                      </a:solidFill>
                    </a:lnL>
                    <a:lnR w="13680">
                      <a:solidFill>
                        <a:srgbClr val="333333"/>
                      </a:solidFill>
                    </a:lnR>
                    <a:lnT w="13680">
                      <a:solidFill>
                        <a:srgbClr val="333333"/>
                      </a:solidFill>
                    </a:lnT>
                    <a:lnB w="13680">
                      <a:solidFill>
                        <a:srgbClr val="333333"/>
                      </a:solidFill>
                    </a:lnB>
                    <a:solidFill>
                      <a:srgbClr val="ec0000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5000"/>
                        </a:lnSpc>
                        <a:spcBef>
                          <a:spcPts val="162"/>
                        </a:spcBef>
                        <a:spcAft>
                          <a:spcPts val="162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egative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ctr" marL="90000" marR="90000">
                    <a:lnL w="13680">
                      <a:solidFill>
                        <a:srgbClr val="333333"/>
                      </a:solidFill>
                    </a:lnL>
                    <a:lnR w="13680">
                      <a:solidFill>
                        <a:srgbClr val="1f6347"/>
                      </a:solidFill>
                    </a:lnR>
                    <a:lnT w="13680">
                      <a:solidFill>
                        <a:srgbClr val="1f6347"/>
                      </a:solidFill>
                    </a:lnT>
                    <a:lnB w="13680">
                      <a:solidFill>
                        <a:srgbClr val="1f6347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5000"/>
                        </a:lnSpc>
                        <a:spcBef>
                          <a:spcPts val="162"/>
                        </a:spcBef>
                        <a:spcAft>
                          <a:spcPts val="162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r=-0.12, </a:t>
                      </a:r>
                      <a:r>
                        <a:rPr b="0" i="1" lang="en-GB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</a:t>
                      </a:r>
                      <a:r>
                        <a:rPr b="0" lang="en-GB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&lt;0.001)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ctr" marL="90000" marR="90000">
                    <a:lnL w="13680">
                      <a:solidFill>
                        <a:srgbClr val="1f6347"/>
                      </a:solidFill>
                    </a:lnL>
                    <a:lnR w="13680">
                      <a:solidFill>
                        <a:srgbClr val="1f6347"/>
                      </a:solidFill>
                    </a:lnR>
                    <a:lnT w="13680">
                      <a:solidFill>
                        <a:srgbClr val="1f6347"/>
                      </a:solidFill>
                    </a:lnT>
                    <a:lnB w="13680">
                      <a:solidFill>
                        <a:srgbClr val="1f6347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124" name=""/>
          <p:cNvSpPr/>
          <p:nvPr/>
        </p:nvSpPr>
        <p:spPr>
          <a:xfrm>
            <a:off x="457200" y="343080"/>
            <a:ext cx="82296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e80000"/>
                </a:solidFill>
                <a:latin typeface="Tahoma"/>
              </a:rPr>
              <a:t>Activity correlations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International Journal of Clinical Practice  www.ijcp.org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AD73CC-C17F-4922-BC17-21341346B5A2}" type="slidenum">
              <a:t>8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26" dur="indefinite" restart="never" nodeType="tmRoot">
          <p:childTnLst>
            <p:seq>
              <p:cTn id="27" dur="indefinite" nodeType="mainSeq">
                <p:childTnLst>
                  <p:par>
                    <p:cTn id="28" fill="hold">
                      <p:stCondLst>
                        <p:cond delay="0"/>
                      </p:stCondLst>
                      <p:childTnLst>
                        <p:par>
                          <p:cTn id="29" fill="hold">
                            <p:stCondLst>
                              <p:cond delay="0"/>
                            </p:stCondLst>
                            <p:childTnLst>
                              <p:par>
                                <p:cTn id="30" nodeType="afterEffect" fill="hold" presetClass="entr" presetID="2" presetSubtype="6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3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2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32" dur="500" fill="hold"/>
                                        <p:tgtEl>
                                          <p:spTgt spid="122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33" dur="500" fill="hold"/>
                                        <p:tgtEl>
                                          <p:spTgt spid="122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4" fill="hold">
                            <p:stCondLst>
                              <p:cond delay="1500"/>
                            </p:stCondLst>
                            <p:childTnLst>
                              <p:par>
                                <p:cTn id="35" nodeType="afterEffect" fill="hold" presetClass="entr" presetID="3" presetSubtype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blinds(horizontal)" transition="in">
                                      <p:cBhvr additive="repl">
                                        <p:cTn id="37" dur="500"/>
                                        <p:tgtEl>
                                          <p:spTgt spid="12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10-24T12:31:02Z</dcterms:created>
  <dc:creator>cgraf</dc:creator>
  <dc:description/>
  <dc:language>en-US</dc:language>
  <cp:lastModifiedBy>cgraf</cp:lastModifiedBy>
  <dcterms:modified xsi:type="dcterms:W3CDTF">2007-10-09T15:12:45Z</dcterms:modified>
  <cp:revision>11</cp:revision>
  <dc:subject/>
  <dc:title>Insert: Full title of your article </dc:title>
</cp:coreProperties>
</file>